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141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903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814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889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722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568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122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302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928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459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038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667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EEAF32-5E93-4ACE-8686-5A46E0EBEA6A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D5399-5D2A-43C8-9304-3C1251845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315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1720" y="116632"/>
            <a:ext cx="4882493" cy="555299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68530" y="5733256"/>
            <a:ext cx="784887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Figure S1.</a:t>
            </a:r>
            <a:r>
              <a:rPr lang="en-GB" sz="1000" dirty="0"/>
              <a:t> Expression levels of genes encoding terminal oxidases. The gene expression values on the Y-axis represent reads per </a:t>
            </a:r>
            <a:r>
              <a:rPr lang="en-GB" sz="1000" dirty="0" err="1"/>
              <a:t>kilobase</a:t>
            </a:r>
            <a:r>
              <a:rPr lang="en-GB" sz="1000" dirty="0"/>
              <a:t> per million mapped reads (RPKM).</a:t>
            </a:r>
            <a:endParaRPr lang="en-US" sz="1000" dirty="0"/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6565122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Sydne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guel Hernandez</dc:creator>
  <cp:lastModifiedBy>Miguel Hernandez</cp:lastModifiedBy>
  <cp:revision>1</cp:revision>
  <dcterms:created xsi:type="dcterms:W3CDTF">2016-12-07T23:41:12Z</dcterms:created>
  <dcterms:modified xsi:type="dcterms:W3CDTF">2016-12-07T23:45:01Z</dcterms:modified>
</cp:coreProperties>
</file>